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92" autoAdjust="0"/>
    <p:restoredTop sz="94660"/>
  </p:normalViewPr>
  <p:slideViewPr>
    <p:cSldViewPr snapToGrid="0">
      <p:cViewPr varScale="1">
        <p:scale>
          <a:sx n="88" d="100"/>
          <a:sy n="88" d="100"/>
        </p:scale>
        <p:origin x="120" y="1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86A570-98C8-4BFF-AD07-851C8146970F}" type="datetimeFigureOut">
              <a:rPr lang="en-US" smtClean="0"/>
              <a:t>12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5A940-A2E8-45CB-8554-00372FC39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92548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86A570-98C8-4BFF-AD07-851C8146970F}" type="datetimeFigureOut">
              <a:rPr lang="en-US" smtClean="0"/>
              <a:t>12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5A940-A2E8-45CB-8554-00372FC39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70727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86A570-98C8-4BFF-AD07-851C8146970F}" type="datetimeFigureOut">
              <a:rPr lang="en-US" smtClean="0"/>
              <a:t>12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5A940-A2E8-45CB-8554-00372FC39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33978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86A570-98C8-4BFF-AD07-851C8146970F}" type="datetimeFigureOut">
              <a:rPr lang="en-US" smtClean="0"/>
              <a:t>12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5A940-A2E8-45CB-8554-00372FC39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48759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86A570-98C8-4BFF-AD07-851C8146970F}" type="datetimeFigureOut">
              <a:rPr lang="en-US" smtClean="0"/>
              <a:t>12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5A940-A2E8-45CB-8554-00372FC39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4960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86A570-98C8-4BFF-AD07-851C8146970F}" type="datetimeFigureOut">
              <a:rPr lang="en-US" smtClean="0"/>
              <a:t>12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5A940-A2E8-45CB-8554-00372FC39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4319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86A570-98C8-4BFF-AD07-851C8146970F}" type="datetimeFigureOut">
              <a:rPr lang="en-US" smtClean="0"/>
              <a:t>12/1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5A940-A2E8-45CB-8554-00372FC39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98555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86A570-98C8-4BFF-AD07-851C8146970F}" type="datetimeFigureOut">
              <a:rPr lang="en-US" smtClean="0"/>
              <a:t>12/1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5A940-A2E8-45CB-8554-00372FC39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9275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86A570-98C8-4BFF-AD07-851C8146970F}" type="datetimeFigureOut">
              <a:rPr lang="en-US" smtClean="0"/>
              <a:t>12/1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5A940-A2E8-45CB-8554-00372FC39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1055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86A570-98C8-4BFF-AD07-851C8146970F}" type="datetimeFigureOut">
              <a:rPr lang="en-US" smtClean="0"/>
              <a:t>12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5A940-A2E8-45CB-8554-00372FC39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16372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86A570-98C8-4BFF-AD07-851C8146970F}" type="datetimeFigureOut">
              <a:rPr lang="en-US" smtClean="0"/>
              <a:t>12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5A940-A2E8-45CB-8554-00372FC39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21353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86A570-98C8-4BFF-AD07-851C8146970F}" type="datetimeFigureOut">
              <a:rPr lang="en-US" smtClean="0"/>
              <a:t>12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55A940-A2E8-45CB-8554-00372FC39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18098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/>
          </p:nvPr>
        </p:nvGraphicFramePr>
        <p:xfrm>
          <a:off x="1981201" y="990600"/>
          <a:ext cx="4267201" cy="289560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775855"/>
                <a:gridCol w="775855"/>
                <a:gridCol w="2715491"/>
              </a:tblGrid>
              <a:tr h="0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 sequences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PRT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TGCCGAGGATTTGGAAAAAG-3’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CCCCCCTTGAGCACACAG-3’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100A8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CCATGCCCTCTACAAGAATG-3’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ATCACCATCGCAAGGAACTC-3’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pinb3a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CAGATGATGAAACAAAACATCG-3’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AGACCTTGAGTGCTGCTCATA-3’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RT6B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AACCTGCAAGCTGCTAT-3’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CTTGACATTCATGAGTTCCTGGTA-3’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DN23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AGAAAAGAAGACAGCCACCTC-3’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CAGAAG TTCAAGTCACCCTCAG-3’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FB4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GATCCATTACCTTCTCTTCACATTTC-3’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CTCCATTGGTCATGCATGTTATT-3’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L22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CTTCTTGCTGTGGCAATTC-3’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TGATGGCAGAGGGTGAC-3’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R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ACATCAGCATCACCTCCTTC-3’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TCTTTCCACAACCCACAGG-3’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T6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AGCGACAGCCTCTACTACTT-3’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CGGCACTCTGTGCTTTCTAT-3’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</a:tr>
            </a:tbl>
          </a:graphicData>
        </a:graphic>
      </p:graphicFrame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1752600" y="304800"/>
            <a:ext cx="8686800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US" altLang="en-US" sz="1400" dirty="0" err="1">
                <a:latin typeface="Times New Roman" panose="02020603050405020304" pitchFamily="18" charset="0"/>
                <a:ea typeface="Times New Roman" pitchFamily="18" charset="0"/>
                <a:cs typeface="Times New Roman" panose="02020603050405020304" pitchFamily="18" charset="0"/>
              </a:rPr>
              <a:t>S1</a:t>
            </a:r>
            <a:r>
              <a:rPr lang="en-US" altLang="en-US" sz="1400" dirty="0">
                <a:latin typeface="Times New Roman" panose="02020603050405020304" pitchFamily="18" charset="0"/>
                <a:ea typeface="Times New Roman" pitchFamily="18" charset="0"/>
                <a:cs typeface="Times New Roman" panose="02020603050405020304" pitchFamily="18" charset="0"/>
              </a:rPr>
              <a:t> Table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 sequences for genes validated using qPCR.</a:t>
            </a:r>
          </a:p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422963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3</Words>
  <Application>Microsoft Office PowerPoint</Application>
  <PresentationFormat>Widescreen</PresentationFormat>
  <Paragraphs>5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uglas Surwilo</dc:creator>
  <cp:lastModifiedBy>Douglas Surwilo</cp:lastModifiedBy>
  <cp:revision>1</cp:revision>
  <dcterms:created xsi:type="dcterms:W3CDTF">2015-12-11T19:30:08Z</dcterms:created>
  <dcterms:modified xsi:type="dcterms:W3CDTF">2015-12-11T19:30:43Z</dcterms:modified>
</cp:coreProperties>
</file>